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83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44C267-35C1-478E-BA22-680FAC41EB2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C0A875A-B382-4A35-963D-ED443B3F2D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98D9A00-79E3-49DE-B242-ABFBC2B66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987FE7-396C-43BF-A2BD-404B2F0CF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94661D3-32D9-4CE9-AFE6-0E5B6EAB7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5000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2EB384-5742-4668-8EC1-69B7EB682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4C1D792-473D-46EF-8D91-DE33D8222A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DB9FA4-23A3-4E60-9B54-76511868D5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BA9F43-67A7-4057-A010-103E0A8A73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65C5F50-4292-4B98-AAC7-DA5962C80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57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AA31553-475F-4AA5-93B5-9E183437A9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A6A3C75-5609-4404-8C8B-9F3FE2EB8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6BA2E9-611A-4399-9E82-E7A39978D4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9794DB5-67C6-439C-9E42-05F859E21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E9F2ED-D385-4345-94D1-CA11F14FB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705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DA51C5-ABA3-4FC9-A2F3-7563DF20ED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B9FD50E-403F-4D57-8940-361B004D56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47D8297-FA98-4EE9-B47E-E813049A7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D4DEED-18A6-4AC5-991F-310217E17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209750A-8908-47B4-8714-32B2C343CB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881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6CDA59-FD0F-4CA3-BA0A-C00712D06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8B3FFCD-14D1-461C-B59A-B710D2D22E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838F20F-A280-4817-A8C2-ED93CD333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78084DC-ED29-4E00-961A-07B27F731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1F6A6A-0BE3-439D-A50C-ADA88D9C4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4417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29E9A3-FB16-45DA-B08A-F0F9E97597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7BB6399-3992-4247-8710-9084C4739F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414424B-E29C-4241-910A-045BAD738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A6F1222-E826-46B0-BF4E-1BD08D1AC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E129A6C-36BB-4CF7-948D-3F2E33638A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26E5911-D2FD-4ABB-8CE5-965D860E0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7754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FF5542-14E6-4550-8263-3AE35C825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2DBBB2AC-1117-4860-B1F3-9CFC4DBC6E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7413A62-F295-4C0F-BAE0-D30BB5BFB1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D161194-4883-4EF7-9CFB-D820506D24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6B91F28-7539-4B13-897F-0C85BD2599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67DD107-54A6-4855-B922-30A636529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2A2F70A-FF1A-4729-B73E-EF2D2AA98F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EDE6ACE-FB53-48F9-987E-18CA7C242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013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ABFCA3-EAC9-4C4A-9256-51E5B36DEE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1825C5C-1939-45B1-B691-8064A9F48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4BBCC3B-E185-4FC9-8B4D-EFF679E3A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DABA4B7-5146-449E-ACD0-2287007D0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3216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3396AA7-4FE4-4224-828D-4D9D1E02B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2115696-032C-4FA6-A1A6-9D793804F2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BA1E480-A370-402E-B49E-09ED2AB01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7061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94532C2-2B70-45BA-B106-F910F86313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C87814D-75BB-476F-A1C3-26CE561189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11AD63A-B17D-40D0-B2FE-902FC953C2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C02BB00-9458-4E9F-B99E-D99AE09CF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7EDBA8A-33FE-42E3-BC90-B605F1E6A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6D73763-E787-4C35-B1F3-8C7163141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464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0CF06FE-F8E9-4E8F-8194-23CD84C64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D5BDD28-8655-4952-BD5A-BD81F38065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7FAB26E-23A5-4866-AD68-D49D5C3319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CF7EDBB-205B-4E52-AE82-A7F77902C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66F7DB3-3218-4384-81DB-39158E0C9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72467A2-3F57-4F80-B8F5-2BE022B44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522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0E7F863-CB19-490F-A549-46A0818B3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29C3EBE-B7E2-4DD8-B12D-E5AF472A9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3E2A42E-D9ED-4556-885A-AC82625860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F79B2E-EB92-428F-9601-CFA0D8311A89}" type="datetimeFigureOut">
              <a:rPr lang="en-GB" smtClean="0"/>
              <a:t>26/12/2021</a:t>
            </a:fld>
            <a:endParaRPr lang="en-GB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45A9712-79D2-4C0A-9D07-523125F287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2206F20-5D95-467D-BBBA-43ADB8EB12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395C1-EFEC-4969-9F7F-C7A9A68C51CA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2586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E4D3020B-28A7-4B9F-BC51-0461509B39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2766" y="816989"/>
            <a:ext cx="7866467" cy="4069335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EF2DCEFB-88A6-4EF7-B060-6CB0C865EC2C}"/>
              </a:ext>
            </a:extLst>
          </p:cNvPr>
          <p:cNvSpPr txBox="1"/>
          <p:nvPr/>
        </p:nvSpPr>
        <p:spPr>
          <a:xfrm>
            <a:off x="2019863" y="5167392"/>
            <a:ext cx="80102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Figure S7: </a:t>
            </a:r>
            <a:r>
              <a:rPr lang="en-GB" sz="1200" dirty="0" err="1">
                <a:cs typeface="Times New Roman" panose="02020603050405020304" pitchFamily="18" charset="0"/>
              </a:rPr>
              <a:t>Extensin</a:t>
            </a:r>
            <a:r>
              <a:rPr lang="en-GB" sz="1200" dirty="0">
                <a:cs typeface="Times New Roman" panose="02020603050405020304" pitchFamily="18" charset="0"/>
              </a:rPr>
              <a:t> gene region (9:232692750-232694483_ID: PHT73052.1). Highlighted in yellow the mutation site (Insertion of adenine T -&gt; TA in genotypes from Campania). Flanking primers are highlighted in red (</a:t>
            </a:r>
            <a:r>
              <a:rPr lang="en-GB" sz="1200" dirty="0" err="1">
                <a:cs typeface="Times New Roman" panose="02020603050405020304" pitchFamily="18" charset="0"/>
              </a:rPr>
              <a:t>ExtF</a:t>
            </a:r>
            <a:r>
              <a:rPr lang="en-GB" sz="1200" dirty="0">
                <a:cs typeface="Times New Roman" panose="02020603050405020304" pitchFamily="18" charset="0"/>
              </a:rPr>
              <a:t>) and blue (reverse complement of </a:t>
            </a:r>
            <a:r>
              <a:rPr lang="en-GB" sz="1200" dirty="0" err="1">
                <a:cs typeface="Times New Roman" panose="02020603050405020304" pitchFamily="18" charset="0"/>
              </a:rPr>
              <a:t>ExtR</a:t>
            </a:r>
            <a:r>
              <a:rPr lang="en-GB" sz="1200" dirty="0">
                <a:cs typeface="Times New Roman" panose="02020603050405020304" pitchFamily="18" charset="0"/>
              </a:rPr>
              <a:t>) font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5016837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ripodi</dc:creator>
  <cp:lastModifiedBy>pasquale tripodi</cp:lastModifiedBy>
  <cp:revision>5</cp:revision>
  <dcterms:created xsi:type="dcterms:W3CDTF">2021-12-16T21:56:14Z</dcterms:created>
  <dcterms:modified xsi:type="dcterms:W3CDTF">2021-12-26T14:44:40Z</dcterms:modified>
</cp:coreProperties>
</file>